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643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 om de ondertitelstijl van het model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A09E2-D832-40BA-BAF5-7C202E5C2EE8}" type="datetimeFigureOut">
              <a:rPr lang="nl-NL" smtClean="0"/>
              <a:t>30-3-202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DE8E3-0916-4882-97C8-862A21C077F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91179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A09E2-D832-40BA-BAF5-7C202E5C2EE8}" type="datetimeFigureOut">
              <a:rPr lang="nl-NL" smtClean="0"/>
              <a:t>30-3-202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DE8E3-0916-4882-97C8-862A21C077F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49592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A09E2-D832-40BA-BAF5-7C202E5C2EE8}" type="datetimeFigureOut">
              <a:rPr lang="nl-NL" smtClean="0"/>
              <a:t>30-3-202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DE8E3-0916-4882-97C8-862A21C077F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12958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A09E2-D832-40BA-BAF5-7C202E5C2EE8}" type="datetimeFigureOut">
              <a:rPr lang="nl-NL" smtClean="0"/>
              <a:t>30-3-202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DE8E3-0916-4882-97C8-862A21C077F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82289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A09E2-D832-40BA-BAF5-7C202E5C2EE8}" type="datetimeFigureOut">
              <a:rPr lang="nl-NL" smtClean="0"/>
              <a:t>30-3-202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DE8E3-0916-4882-97C8-862A21C077F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12804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A09E2-D832-40BA-BAF5-7C202E5C2EE8}" type="datetimeFigureOut">
              <a:rPr lang="nl-NL" smtClean="0"/>
              <a:t>30-3-2022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DE8E3-0916-4882-97C8-862A21C077F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065704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A09E2-D832-40BA-BAF5-7C202E5C2EE8}" type="datetimeFigureOut">
              <a:rPr lang="nl-NL" smtClean="0"/>
              <a:t>30-3-2022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DE8E3-0916-4882-97C8-862A21C077F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77600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A09E2-D832-40BA-BAF5-7C202E5C2EE8}" type="datetimeFigureOut">
              <a:rPr lang="nl-NL" smtClean="0"/>
              <a:t>30-3-2022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DE8E3-0916-4882-97C8-862A21C077F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26874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A09E2-D832-40BA-BAF5-7C202E5C2EE8}" type="datetimeFigureOut">
              <a:rPr lang="nl-NL" smtClean="0"/>
              <a:t>30-3-2022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DE8E3-0916-4882-97C8-862A21C077F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19999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A09E2-D832-40BA-BAF5-7C202E5C2EE8}" type="datetimeFigureOut">
              <a:rPr lang="nl-NL" smtClean="0"/>
              <a:t>30-3-2022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DE8E3-0916-4882-97C8-862A21C077F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93197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A09E2-D832-40BA-BAF5-7C202E5C2EE8}" type="datetimeFigureOut">
              <a:rPr lang="nl-NL" smtClean="0"/>
              <a:t>30-3-2022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DE8E3-0916-4882-97C8-862A21C077F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30328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A09E2-D832-40BA-BAF5-7C202E5C2EE8}" type="datetimeFigureOut">
              <a:rPr lang="nl-NL" smtClean="0"/>
              <a:t>30-3-202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FDE8E3-0916-4882-97C8-862A21C077F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12164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343593" y="443202"/>
            <a:ext cx="9144000" cy="1655762"/>
          </a:xfrm>
        </p:spPr>
        <p:txBody>
          <a:bodyPr>
            <a:normAutofit/>
          </a:bodyPr>
          <a:lstStyle/>
          <a:p>
            <a:pPr algn="l"/>
            <a:r>
              <a:rPr lang="nl-NL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digital </a:t>
            </a:r>
            <a:r>
              <a:rPr lang="nl-NL" sz="1600" b="1">
                <a:latin typeface="Arial" panose="020B0604020202020204" pitchFamily="34" charset="0"/>
                <a:cs typeface="Arial" panose="020B0604020202020204" pitchFamily="34" charset="0"/>
              </a:rPr>
              <a:t>content 6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he change in predicted mortality is presented if the 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</a:rPr>
              <a:t>ED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cute Physiology and Chronic Health Evaluation (APACHE)-IV is compared to the 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</a:rPr>
              <a:t>ICU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PACHE-IV score. Both scores are presented per category that predicted mortality changed, with the number of patients in each group. </a:t>
            </a:r>
            <a:endParaRPr lang="nl-NL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kstvak 4"/>
          <p:cNvSpPr txBox="1"/>
          <p:nvPr/>
        </p:nvSpPr>
        <p:spPr>
          <a:xfrm>
            <a:off x="875780" y="4887883"/>
            <a:ext cx="369085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err="1"/>
              <a:t>Number</a:t>
            </a:r>
            <a:r>
              <a:rPr lang="nl-NL" dirty="0"/>
              <a:t> of </a:t>
            </a:r>
            <a:r>
              <a:rPr lang="nl-NL" dirty="0" err="1"/>
              <a:t>patients</a:t>
            </a:r>
            <a:r>
              <a:rPr lang="nl-NL" dirty="0"/>
              <a:t> per </a:t>
            </a:r>
            <a:r>
              <a:rPr lang="nl-NL" dirty="0" err="1"/>
              <a:t>group</a:t>
            </a:r>
            <a:r>
              <a:rPr lang="nl-NL" dirty="0"/>
              <a:t>:</a:t>
            </a:r>
          </a:p>
          <a:p>
            <a:r>
              <a:rPr lang="nl-NL" dirty="0"/>
              <a:t>&lt;-5%:  	N=1 (0.1%)</a:t>
            </a:r>
          </a:p>
          <a:p>
            <a:r>
              <a:rPr lang="nl-NL" dirty="0"/>
              <a:t>05 – 5%: 	N=1066 (76.9%)</a:t>
            </a:r>
          </a:p>
          <a:p>
            <a:r>
              <a:rPr lang="nl-NL" dirty="0"/>
              <a:t>5-10%:	N=202 (14.6%)</a:t>
            </a:r>
          </a:p>
          <a:p>
            <a:r>
              <a:rPr lang="nl-NL" dirty="0"/>
              <a:t>&gt;10%:	N=118 (8.5%)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B643476E-B1D9-4310-A5BF-C6289666349E}"/>
              </a:ext>
            </a:extLst>
          </p:cNvPr>
          <p:cNvGrpSpPr/>
          <p:nvPr/>
        </p:nvGrpSpPr>
        <p:grpSpPr>
          <a:xfrm>
            <a:off x="3752157" y="1600200"/>
            <a:ext cx="8096250" cy="5257800"/>
            <a:chOff x="3752157" y="1600200"/>
            <a:chExt cx="8096250" cy="5257800"/>
          </a:xfrm>
        </p:grpSpPr>
        <p:pic>
          <p:nvPicPr>
            <p:cNvPr id="4" name="Afbeelding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52157" y="1600200"/>
              <a:ext cx="8096250" cy="5257800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C3BDE88A-8070-470D-9ADB-9E51BA34AD3E}"/>
                </a:ext>
              </a:extLst>
            </p:cNvPr>
            <p:cNvSpPr txBox="1"/>
            <p:nvPr/>
          </p:nvSpPr>
          <p:spPr>
            <a:xfrm>
              <a:off x="10021456" y="1729632"/>
              <a:ext cx="72043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nl-NL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9B7205C-08E0-40B4-8F73-A87DB3D65EA4}"/>
                </a:ext>
              </a:extLst>
            </p:cNvPr>
            <p:cNvSpPr txBox="1"/>
            <p:nvPr/>
          </p:nvSpPr>
          <p:spPr>
            <a:xfrm>
              <a:off x="10330049" y="1840592"/>
              <a:ext cx="4395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/>
                <a:t>ED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F3B7882F-BB92-408A-A7BA-E7A7173F6FA6}"/>
                </a:ext>
              </a:extLst>
            </p:cNvPr>
            <p:cNvSpPr/>
            <p:nvPr/>
          </p:nvSpPr>
          <p:spPr>
            <a:xfrm>
              <a:off x="10021456" y="2327564"/>
              <a:ext cx="600362" cy="1939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060A8E1-A9D9-4F54-8565-7F19CE3906BD}"/>
                </a:ext>
              </a:extLst>
            </p:cNvPr>
            <p:cNvSpPr txBox="1"/>
            <p:nvPr/>
          </p:nvSpPr>
          <p:spPr>
            <a:xfrm>
              <a:off x="10182428" y="2228396"/>
              <a:ext cx="5132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/>
                <a:t>ICU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76017651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00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 Presentation</vt:lpstr>
    </vt:vector>
  </TitlesOfParts>
  <Company>A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Candel, B.G.J. (Bart)</dc:creator>
  <cp:lastModifiedBy>Candel, B.G.J. (SEH)</cp:lastModifiedBy>
  <cp:revision>12</cp:revision>
  <dcterms:created xsi:type="dcterms:W3CDTF">2021-10-06T13:51:07Z</dcterms:created>
  <dcterms:modified xsi:type="dcterms:W3CDTF">2022-03-30T14:56:15Z</dcterms:modified>
</cp:coreProperties>
</file>